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8D46E-F274-46D8-99FD-637AD25991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F3AD6F-6B6C-4363-9EA9-E0CE2F5160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7D09F-74F8-42C9-A67E-1C91C170710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C1A358-18C4-41C5-A81E-001F7BB432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FDF05-E11E-464A-9A36-3E7FA5F3D9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BE4403-D04E-4CDC-89F0-D8370B6B69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AED40-11EB-49BF-885E-A69BB8A745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EB531C-5237-49BE-B4DB-D47BE65A15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6527A6-9272-4B19-A98A-C8FBF218A7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6F7D0E-0F70-47B3-8214-84FDCA9991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ED3F4-C15E-455B-951A-33C206167B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C3D13C-9E4F-4D45-88D7-546B670F50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B4B843-141B-486D-877F-629ACD4AD12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5"/>
          <p:cNvSpPr/>
          <p:nvPr/>
        </p:nvSpPr>
        <p:spPr>
          <a:xfrm>
            <a:off x="228600" y="6019920"/>
            <a:ext cx="8534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le 8: KEGG pathway for Biosynthesis of plant hormones: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8 differentially expressed unigenes under drought stress were identified as a candidates involves in different plant hormones such as Jasmonic acid, ethylene and salicylic acid and Gibberelli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7"/>
          <p:cNvGrpSpPr/>
          <p:nvPr/>
        </p:nvGrpSpPr>
        <p:grpSpPr>
          <a:xfrm>
            <a:off x="117720" y="457200"/>
            <a:ext cx="8422920" cy="5562720"/>
            <a:chOff x="117720" y="457200"/>
            <a:chExt cx="8422920" cy="5562720"/>
          </a:xfrm>
        </p:grpSpPr>
        <p:grpSp>
          <p:nvGrpSpPr>
            <p:cNvPr id="43" name="Group 13"/>
            <p:cNvGrpSpPr/>
            <p:nvPr/>
          </p:nvGrpSpPr>
          <p:grpSpPr>
            <a:xfrm>
              <a:off x="304920" y="457200"/>
              <a:ext cx="8235720" cy="5562720"/>
              <a:chOff x="304920" y="457200"/>
              <a:chExt cx="8235720" cy="5562720"/>
            </a:xfrm>
          </p:grpSpPr>
          <p:pic>
            <p:nvPicPr>
              <p:cNvPr id="44" name="Picture 2" descr=""/>
              <p:cNvPicPr/>
              <p:nvPr/>
            </p:nvPicPr>
            <p:blipFill>
              <a:blip r:embed="rId1"/>
              <a:stretch/>
            </p:blipFill>
            <p:spPr>
              <a:xfrm>
                <a:off x="304920" y="457200"/>
                <a:ext cx="8235720" cy="5562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Striped Right Arrow 9"/>
              <p:cNvSpPr/>
              <p:nvPr/>
            </p:nvSpPr>
            <p:spPr>
              <a:xfrm>
                <a:off x="990360" y="5181840"/>
                <a:ext cx="304560" cy="152280"/>
              </a:xfrm>
              <a:prstGeom prst="pie">
                <a:avLst/>
              </a:prstGeom>
              <a:solidFill>
                <a:srgbClr val="4f81bd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Striped Right Arrow 10"/>
              <p:cNvSpPr/>
              <p:nvPr/>
            </p:nvSpPr>
            <p:spPr>
              <a:xfrm rot="2129400">
                <a:off x="7467120" y="609480"/>
                <a:ext cx="304560" cy="152280"/>
              </a:xfrm>
              <a:prstGeom prst="pie">
                <a:avLst/>
              </a:prstGeom>
              <a:solidFill>
                <a:srgbClr val="4f81bd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Striped Right Arrow 11"/>
              <p:cNvSpPr/>
              <p:nvPr/>
            </p:nvSpPr>
            <p:spPr>
              <a:xfrm rot="2129400">
                <a:off x="4130280" y="1293840"/>
                <a:ext cx="304560" cy="152280"/>
              </a:xfrm>
              <a:prstGeom prst="pie">
                <a:avLst/>
              </a:prstGeom>
              <a:solidFill>
                <a:srgbClr val="4f81bd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Striped Right Arrow 12"/>
              <p:cNvSpPr/>
              <p:nvPr/>
            </p:nvSpPr>
            <p:spPr>
              <a:xfrm rot="2129400">
                <a:off x="7254360" y="5027760"/>
                <a:ext cx="304560" cy="152280"/>
              </a:xfrm>
              <a:prstGeom prst="pie">
                <a:avLst/>
              </a:prstGeom>
              <a:solidFill>
                <a:srgbClr val="4f81bd"/>
              </a:solidFill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9" name="TextBox 14"/>
            <p:cNvSpPr/>
            <p:nvPr/>
          </p:nvSpPr>
          <p:spPr>
            <a:xfrm>
              <a:off x="117720" y="533160"/>
              <a:ext cx="3231720" cy="368280"/>
            </a:xfrm>
            <a:prstGeom prst="rect">
              <a:avLst/>
            </a:prstGeom>
            <a:solidFill>
              <a:srgbClr val="ffc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Biosynthesis of plant hormones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Striped Right Arrow 16"/>
            <p:cNvSpPr/>
            <p:nvPr/>
          </p:nvSpPr>
          <p:spPr>
            <a:xfrm rot="2129400">
              <a:off x="396360" y="2513160"/>
              <a:ext cx="304560" cy="152280"/>
            </a:xfrm>
            <a:prstGeom prst="pie">
              <a:avLst/>
            </a:prstGeom>
            <a:solidFill>
              <a:srgbClr val="4f81bd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01T04:36:58Z</dcterms:created>
  <dc:creator>Lenovo</dc:creator>
  <dc:description/>
  <dc:language>en-US</dc:language>
  <cp:lastModifiedBy>amit deokar</cp:lastModifiedBy>
  <dcterms:modified xsi:type="dcterms:W3CDTF">2011-02-10T10:09:59Z</dcterms:modified>
  <cp:revision>12</cp:revision>
  <dc:subject/>
  <dc:title>Slide 1</dc:title>
</cp:coreProperties>
</file>